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7" r:id="rId3"/>
  </p:sldIdLst>
  <p:sldSz cx="9144000" cy="6858000" type="screen4x3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107" d="100"/>
          <a:sy n="107" d="100"/>
        </p:scale>
        <p:origin x="9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2FEC0-046F-0244-8271-A5A9E829D684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D5B08-F425-8B4C-B566-2AC7AEE327B2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670426" y="162480"/>
            <a:ext cx="2833434" cy="658946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K Biobank Total Number of Participant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502, 392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670426" y="1710789"/>
            <a:ext cx="2833429" cy="658800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ticipants with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2DM at baselin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13, 53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078061" y="810789"/>
            <a:ext cx="0" cy="90000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5702246" y="2456428"/>
            <a:ext cx="2880000" cy="658946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clusion: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ticipants with  neither handgrip strength nor muscle mass data (N=139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250827" y="5114101"/>
            <a:ext cx="1767600" cy="781200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ticipants with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andgrip strength dat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13, 29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6"/>
          <p:cNvSpPr/>
          <p:nvPr/>
        </p:nvSpPr>
        <p:spPr>
          <a:xfrm>
            <a:off x="5702246" y="931389"/>
            <a:ext cx="2880000" cy="658800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xclusion: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rticipants without T2DM at baselin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488, 861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3"/>
          <p:cNvSpPr/>
          <p:nvPr/>
        </p:nvSpPr>
        <p:spPr>
          <a:xfrm>
            <a:off x="2670426" y="3269589"/>
            <a:ext cx="2833200" cy="658800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rticipants included in the final analysis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=13392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Arrow Connector 5"/>
          <p:cNvCxnSpPr/>
          <p:nvPr/>
        </p:nvCxnSpPr>
        <p:spPr>
          <a:xfrm>
            <a:off x="4078061" y="2369589"/>
            <a:ext cx="0" cy="90000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5"/>
          <p:cNvCxnSpPr/>
          <p:nvPr/>
        </p:nvCxnSpPr>
        <p:spPr>
          <a:xfrm>
            <a:off x="2278061" y="4389340"/>
            <a:ext cx="0" cy="72000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/>
          <p:cNvCxnSpPr/>
          <p:nvPr/>
        </p:nvCxnSpPr>
        <p:spPr>
          <a:xfrm>
            <a:off x="4078061" y="1250614"/>
            <a:ext cx="1620000" cy="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>
            <a:off x="4078061" y="2785901"/>
            <a:ext cx="1620000" cy="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9"/>
          <p:cNvSpPr/>
          <p:nvPr/>
        </p:nvSpPr>
        <p:spPr>
          <a:xfrm>
            <a:off x="3202389" y="5114101"/>
            <a:ext cx="1767600" cy="781200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ticipants with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uscle mass dat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12, 81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9"/>
          <p:cNvSpPr/>
          <p:nvPr/>
        </p:nvSpPr>
        <p:spPr>
          <a:xfrm>
            <a:off x="5136865" y="5114101"/>
            <a:ext cx="1765960" cy="780958"/>
          </a:xfrm>
          <a:prstGeom prst="rect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ticipants with data for sarcopenia 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ssificat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12, 71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2278061" y="4389340"/>
            <a:ext cx="3600000" cy="0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4078061" y="3914210"/>
            <a:ext cx="0" cy="475130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5"/>
          <p:cNvCxnSpPr/>
          <p:nvPr/>
        </p:nvCxnSpPr>
        <p:spPr>
          <a:xfrm>
            <a:off x="4078061" y="4389340"/>
            <a:ext cx="0" cy="72000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5"/>
          <p:cNvCxnSpPr/>
          <p:nvPr/>
        </p:nvCxnSpPr>
        <p:spPr>
          <a:xfrm>
            <a:off x="5869096" y="4389340"/>
            <a:ext cx="0" cy="72000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6a5e1f53-ac03-471a-aa30-255b65273fda"/>
  <p:tag name="COMMONDATA" val="eyJoZGlkIjoiYzNmNzQ0NTEwZmZkNjEzZjhkNzU0OGRlZmM3Njc3ODY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441</Words>
  <Application>WPS 演示</Application>
  <PresentationFormat>全屏显示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libri</vt:lpstr>
      <vt:lpstr>微软雅黑</vt:lpstr>
      <vt:lpstr>Arial Unicode MS</vt:lpstr>
      <vt:lpstr>等线 Light</vt:lpstr>
      <vt:lpstr>Calibri Light</vt:lpstr>
      <vt:lpstr>等线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Zbar</dc:creator>
  <cp:lastModifiedBy>Someday</cp:lastModifiedBy>
  <cp:revision>9</cp:revision>
  <dcterms:created xsi:type="dcterms:W3CDTF">2023-01-14T01:45:00Z</dcterms:created>
  <dcterms:modified xsi:type="dcterms:W3CDTF">2023-02-05T13:57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5D8B1CF7AA24B86B767EBD0AE667D33</vt:lpwstr>
  </property>
  <property fmtid="{D5CDD505-2E9C-101B-9397-08002B2CF9AE}" pid="3" name="KSOProductBuildVer">
    <vt:lpwstr>2052-11.1.0.13703</vt:lpwstr>
  </property>
</Properties>
</file>